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-1560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45891-6CBA-408F-93D8-2C079A0FF5CF}" type="datetimeFigureOut">
              <a:rPr lang="zh-CN" altLang="en-US" smtClean="0"/>
              <a:t>2019/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96264-ABA1-4A93-8CA9-E8A3CC290D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7025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45891-6CBA-408F-93D8-2C079A0FF5CF}" type="datetimeFigureOut">
              <a:rPr lang="zh-CN" altLang="en-US" smtClean="0"/>
              <a:t>2019/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96264-ABA1-4A93-8CA9-E8A3CC290D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22520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45891-6CBA-408F-93D8-2C079A0FF5CF}" type="datetimeFigureOut">
              <a:rPr lang="zh-CN" altLang="en-US" smtClean="0"/>
              <a:t>2019/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96264-ABA1-4A93-8CA9-E8A3CC290D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55869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45891-6CBA-408F-93D8-2C079A0FF5CF}" type="datetimeFigureOut">
              <a:rPr lang="zh-CN" altLang="en-US" smtClean="0"/>
              <a:t>2019/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96264-ABA1-4A93-8CA9-E8A3CC290D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24931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45891-6CBA-408F-93D8-2C079A0FF5CF}" type="datetimeFigureOut">
              <a:rPr lang="zh-CN" altLang="en-US" smtClean="0"/>
              <a:t>2019/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96264-ABA1-4A93-8CA9-E8A3CC290D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35436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45891-6CBA-408F-93D8-2C079A0FF5CF}" type="datetimeFigureOut">
              <a:rPr lang="zh-CN" altLang="en-US" smtClean="0"/>
              <a:t>2019/1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96264-ABA1-4A93-8CA9-E8A3CC290D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18419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45891-6CBA-408F-93D8-2C079A0FF5CF}" type="datetimeFigureOut">
              <a:rPr lang="zh-CN" altLang="en-US" smtClean="0"/>
              <a:t>2019/1/3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96264-ABA1-4A93-8CA9-E8A3CC290D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28145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45891-6CBA-408F-93D8-2C079A0FF5CF}" type="datetimeFigureOut">
              <a:rPr lang="zh-CN" altLang="en-US" smtClean="0"/>
              <a:t>2019/1/3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96264-ABA1-4A93-8CA9-E8A3CC290D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07811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45891-6CBA-408F-93D8-2C079A0FF5CF}" type="datetimeFigureOut">
              <a:rPr lang="zh-CN" altLang="en-US" smtClean="0"/>
              <a:t>2019/1/3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96264-ABA1-4A93-8CA9-E8A3CC290D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41945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45891-6CBA-408F-93D8-2C079A0FF5CF}" type="datetimeFigureOut">
              <a:rPr lang="zh-CN" altLang="en-US" smtClean="0"/>
              <a:t>2019/1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96264-ABA1-4A93-8CA9-E8A3CC290D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42043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45891-6CBA-408F-93D8-2C079A0FF5CF}" type="datetimeFigureOut">
              <a:rPr lang="zh-CN" altLang="en-US" smtClean="0"/>
              <a:t>2019/1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96264-ABA1-4A93-8CA9-E8A3CC290D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53538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D45891-6CBA-408F-93D8-2C079A0FF5CF}" type="datetimeFigureOut">
              <a:rPr lang="zh-CN" altLang="en-US" smtClean="0"/>
              <a:t>2019/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E96264-ABA1-4A93-8CA9-E8A3CC290D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37623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组合 8"/>
          <p:cNvGrpSpPr/>
          <p:nvPr/>
        </p:nvGrpSpPr>
        <p:grpSpPr>
          <a:xfrm>
            <a:off x="-6032" y="116632"/>
            <a:ext cx="9144000" cy="6602090"/>
            <a:chOff x="-6032" y="116632"/>
            <a:chExt cx="9144000" cy="6602090"/>
          </a:xfrm>
        </p:grpSpPr>
        <p:sp>
          <p:nvSpPr>
            <p:cNvPr id="4" name="TextBox 3"/>
            <p:cNvSpPr txBox="1"/>
            <p:nvPr/>
          </p:nvSpPr>
          <p:spPr>
            <a:xfrm>
              <a:off x="5720" y="116632"/>
              <a:ext cx="9132248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2400" b="1" dirty="0" smtClean="0"/>
                <a:t>Network pharmacology deciphering mechanisms of volatiles of </a:t>
              </a:r>
              <a:r>
                <a:rPr lang="en-US" altLang="zh-CN" sz="2400" b="1" i="1" dirty="0" err="1" smtClean="0"/>
                <a:t>Wendan</a:t>
              </a:r>
              <a:r>
                <a:rPr lang="en-US" altLang="zh-CN" sz="2400" b="1" dirty="0" smtClean="0"/>
                <a:t> granule for the treatment of Alzheimer’s disease</a:t>
              </a:r>
              <a:endParaRPr lang="zh-CN" altLang="en-US" sz="2400" b="1" dirty="0"/>
            </a:p>
          </p:txBody>
        </p:sp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6032" y="1163653"/>
              <a:ext cx="9144000" cy="5185737"/>
            </a:xfrm>
            <a:prstGeom prst="rect">
              <a:avLst/>
            </a:prstGeom>
          </p:spPr>
        </p:pic>
        <p:sp>
          <p:nvSpPr>
            <p:cNvPr id="8" name="矩形 7"/>
            <p:cNvSpPr/>
            <p:nvPr/>
          </p:nvSpPr>
          <p:spPr>
            <a:xfrm>
              <a:off x="5720" y="6349390"/>
              <a:ext cx="8922314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b="1" dirty="0" smtClean="0"/>
                <a:t>Graphical Abstract</a:t>
              </a:r>
              <a:r>
                <a:rPr lang="en-US" altLang="zh-CN" sz="1200" dirty="0" smtClean="0"/>
                <a:t>: </a:t>
              </a:r>
              <a:r>
                <a:rPr lang="en-US" altLang="zh-CN" dirty="0" smtClean="0"/>
                <a:t>the detailed flowchart of our network pharmacological study procedure.</a:t>
              </a:r>
              <a:endParaRPr lang="zh-CN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32499442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28</Words>
  <Application>Microsoft Office PowerPoint</Application>
  <PresentationFormat>全屏显示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gocheck</dc:creator>
  <cp:lastModifiedBy>gocheck</cp:lastModifiedBy>
  <cp:revision>3</cp:revision>
  <dcterms:created xsi:type="dcterms:W3CDTF">2018-06-30T10:06:36Z</dcterms:created>
  <dcterms:modified xsi:type="dcterms:W3CDTF">2019-01-30T08:59:55Z</dcterms:modified>
</cp:coreProperties>
</file>